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D2507-E821-4732-BE9B-4B132A895B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058DE3-1EC0-4923-A52E-8EF4C50DD2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6127D-C4B3-4124-8B72-B99D2921EE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A662C-2E0A-4075-9850-A50265DCF0D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C2CBEC-6DA4-45BC-A1A7-A12B178255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77EA3-39A8-47FF-A823-9A2F2B4D68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B3B01-3917-4B32-A497-E1714C2E70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8A7B05-62FE-46D1-850E-4958A57515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EA99F-90E0-423F-A4CB-DBF1863A22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1D3CF-80D2-42C7-B4B0-9712CCFDE7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88359-6844-4323-90D6-F8E9A71C75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250F3-4EA1-499B-A03A-0D654835D4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4A6A97-24EF-47A2-94A6-C57D701A43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0880" y="1752480"/>
          <a:ext cx="8534520" cy="2057400"/>
        </p:xfrm>
        <a:graphic>
          <a:graphicData uri="http://schemas.openxmlformats.org/drawingml/2006/table">
            <a:tbl>
              <a:tblPr/>
              <a:tblGrid>
                <a:gridCol w="1514520"/>
                <a:gridCol w="1017720"/>
                <a:gridCol w="1017360"/>
                <a:gridCol w="1065240"/>
                <a:gridCol w="1143000"/>
                <a:gridCol w="925560"/>
                <a:gridCol w="925560"/>
                <a:gridCol w="925560"/>
              </a:tblGrid>
              <a:tr h="387000"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Villag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pul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Sera Tes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No. of Positive Ser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Positive rate 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%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b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(2005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API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5457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51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Yeonche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,0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.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4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Cheongsa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4,6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5.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47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Tot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11,6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2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3.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굴림"/>
                        </a:rPr>
                        <a:t>0.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12"/>
          <p:cNvSpPr/>
          <p:nvPr/>
        </p:nvSpPr>
        <p:spPr>
          <a:xfrm>
            <a:off x="457200" y="1258920"/>
            <a:ext cx="6858000" cy="41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굴림"/>
              </a:rPr>
              <a:t>4. Positive rate of fluorescent antibody responses of sera in Yeoncheon surveyed are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24"/>
          <p:cNvSpPr/>
          <p:nvPr/>
        </p:nvSpPr>
        <p:spPr>
          <a:xfrm>
            <a:off x="762120" y="3962520"/>
            <a:ext cx="7238880" cy="163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Note.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   a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IFAT; Indirect fluorescent antibody test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API; Annual antibody positive index determined by IF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API; Annual parasite index of 2005 and 200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* Significant between AAPI and positive rate of IFAT was analyzed by Two-way ANOVA (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 =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0.5699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#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positive rate of IFAT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9076, 2006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5674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         </a:t>
            </a:r>
            <a:r>
              <a:rPr b="0" lang="en-US" sz="1000" spc="-1" strike="noStrike" baseline="30000">
                <a:solidFill>
                  <a:srgbClr val="000000"/>
                </a:solidFill>
                <a:latin typeface="Times New Roman"/>
                <a:ea typeface="굴림"/>
              </a:rPr>
              <a:t>&amp;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Significant between API  and AAPI was analyzed by Two-way ANOVA (2005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4478, 2006;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P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 = 0.0116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7018200" y="1476360"/>
            <a:ext cx="184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8T01:58:45Z</dcterms:created>
  <dc:creator>Lee</dc:creator>
  <dc:description/>
  <dc:language>en-US</dc:language>
  <cp:lastModifiedBy>Marcel Hommel</cp:lastModifiedBy>
  <dcterms:modified xsi:type="dcterms:W3CDTF">2012-07-22T10:29:50Z</dcterms:modified>
  <cp:revision>3</cp:revision>
  <dc:subject/>
  <dc:title>Slide 1</dc:title>
</cp:coreProperties>
</file>